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76846" y="487226"/>
            <a:ext cx="6276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3 Table: Variants of Uncertain significance in the </a:t>
            </a:r>
            <a:r>
              <a:rPr lang="en-IN" b="1" i="1" dirty="0" smtClean="0">
                <a:latin typeface="Times New Roman" pitchFamily="18" charset="0"/>
                <a:cs typeface="Times New Roman" pitchFamily="18" charset="0"/>
              </a:rPr>
              <a:t>DMD</a:t>
            </a:r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 gene 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1014704" y="1053645"/>
          <a:ext cx="10263378" cy="5299497"/>
        </p:xfrm>
        <a:graphic>
          <a:graphicData uri="http://schemas.openxmlformats.org/drawingml/2006/table">
            <a:tbl>
              <a:tblPr/>
              <a:tblGrid>
                <a:gridCol w="555642">
                  <a:extLst>
                    <a:ext uri="{9D8B030D-6E8A-4147-A177-3AD203B41FA5}">
                      <a16:colId xmlns:a16="http://schemas.microsoft.com/office/drawing/2014/main" val="1972357953"/>
                    </a:ext>
                  </a:extLst>
                </a:gridCol>
                <a:gridCol w="830303">
                  <a:extLst>
                    <a:ext uri="{9D8B030D-6E8A-4147-A177-3AD203B41FA5}">
                      <a16:colId xmlns:a16="http://schemas.microsoft.com/office/drawing/2014/main" val="1937013619"/>
                    </a:ext>
                  </a:extLst>
                </a:gridCol>
                <a:gridCol w="714357">
                  <a:extLst>
                    <a:ext uri="{9D8B030D-6E8A-4147-A177-3AD203B41FA5}">
                      <a16:colId xmlns:a16="http://schemas.microsoft.com/office/drawing/2014/main" val="740721070"/>
                    </a:ext>
                  </a:extLst>
                </a:gridCol>
                <a:gridCol w="943708">
                  <a:extLst>
                    <a:ext uri="{9D8B030D-6E8A-4147-A177-3AD203B41FA5}">
                      <a16:colId xmlns:a16="http://schemas.microsoft.com/office/drawing/2014/main" val="2564014188"/>
                    </a:ext>
                  </a:extLst>
                </a:gridCol>
                <a:gridCol w="774068">
                  <a:extLst>
                    <a:ext uri="{9D8B030D-6E8A-4147-A177-3AD203B41FA5}">
                      <a16:colId xmlns:a16="http://schemas.microsoft.com/office/drawing/2014/main" val="4172744925"/>
                    </a:ext>
                  </a:extLst>
                </a:gridCol>
                <a:gridCol w="868852">
                  <a:extLst>
                    <a:ext uri="{9D8B030D-6E8A-4147-A177-3AD203B41FA5}">
                      <a16:colId xmlns:a16="http://schemas.microsoft.com/office/drawing/2014/main" val="1390131756"/>
                    </a:ext>
                  </a:extLst>
                </a:gridCol>
                <a:gridCol w="1029366">
                  <a:extLst>
                    <a:ext uri="{9D8B030D-6E8A-4147-A177-3AD203B41FA5}">
                      <a16:colId xmlns:a16="http://schemas.microsoft.com/office/drawing/2014/main" val="1747152681"/>
                    </a:ext>
                  </a:extLst>
                </a:gridCol>
                <a:gridCol w="563647">
                  <a:extLst>
                    <a:ext uri="{9D8B030D-6E8A-4147-A177-3AD203B41FA5}">
                      <a16:colId xmlns:a16="http://schemas.microsoft.com/office/drawing/2014/main" val="2060503948"/>
                    </a:ext>
                  </a:extLst>
                </a:gridCol>
                <a:gridCol w="791020">
                  <a:extLst>
                    <a:ext uri="{9D8B030D-6E8A-4147-A177-3AD203B41FA5}">
                      <a16:colId xmlns:a16="http://schemas.microsoft.com/office/drawing/2014/main" val="1966882971"/>
                    </a:ext>
                  </a:extLst>
                </a:gridCol>
                <a:gridCol w="826067">
                  <a:extLst>
                    <a:ext uri="{9D8B030D-6E8A-4147-A177-3AD203B41FA5}">
                      <a16:colId xmlns:a16="http://schemas.microsoft.com/office/drawing/2014/main" val="1010422909"/>
                    </a:ext>
                  </a:extLst>
                </a:gridCol>
                <a:gridCol w="1183827">
                  <a:extLst>
                    <a:ext uri="{9D8B030D-6E8A-4147-A177-3AD203B41FA5}">
                      <a16:colId xmlns:a16="http://schemas.microsoft.com/office/drawing/2014/main" val="2178743368"/>
                    </a:ext>
                  </a:extLst>
                </a:gridCol>
                <a:gridCol w="1182521">
                  <a:extLst>
                    <a:ext uri="{9D8B030D-6E8A-4147-A177-3AD203B41FA5}">
                      <a16:colId xmlns:a16="http://schemas.microsoft.com/office/drawing/2014/main" val="47297425"/>
                    </a:ext>
                  </a:extLst>
                </a:gridCol>
              </a:tblGrid>
              <a:tr h="1019914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.No</a:t>
                      </a:r>
                      <a:endParaRPr lang="en-I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tient I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at diagnosis (Years)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inical Diagnosis 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when started walking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e at onset of symptom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tion status - at the time of diagnosi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isea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ation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ari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ino acid chang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ype of mutation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5233023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-87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D</a:t>
                      </a:r>
                      <a:endParaRPr lang="en-I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Availabl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1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2273A&gt;C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p758Ala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2700940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-715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?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5 year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12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1363C&gt;G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n455Glu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305727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I-1115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 year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, B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3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4236A&gt;C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ys1412Asn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7690884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I-127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5 year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, B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1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2251C&gt;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g751Trp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1951538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I-1500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 years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Availabl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Availabl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, B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2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2667A&gt;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rg889(=)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8842498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I-165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Availabl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xon 1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1329C&gt;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r443(=)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le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481714"/>
                  </a:ext>
                </a:extLst>
              </a:tr>
              <a:tr h="611369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I-1736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n ambulant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D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on 11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310C&gt;G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437Gly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</a:t>
                      </a:r>
                    </a:p>
                  </a:txBody>
                  <a:tcPr marL="6279" marR="6279" marT="62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10310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91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Microsoft Office PowerPoint</Application>
  <PresentationFormat>Widescreen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3</cp:revision>
  <dcterms:created xsi:type="dcterms:W3CDTF">2020-01-14T07:41:46Z</dcterms:created>
  <dcterms:modified xsi:type="dcterms:W3CDTF">2020-01-14T07:44:17Z</dcterms:modified>
</cp:coreProperties>
</file>